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" d="100"/>
          <a:sy n="40" d="100"/>
        </p:scale>
        <p:origin x="1878" y="-16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4B8A974F-5510-499D-8842-356C8A3E0C54}"/>
    <pc:docChg chg="modSld">
      <pc:chgData name="Franz, Alexander" userId="302c93c3-6320-4d3c-a68d-a1fdc247d2f3" providerId="ADAL" clId="{4B8A974F-5510-499D-8842-356C8A3E0C54}" dt="2025-06-16T20:09:58.816" v="9" actId="1038"/>
      <pc:docMkLst>
        <pc:docMk/>
      </pc:docMkLst>
      <pc:sldChg chg="modSp mod">
        <pc:chgData name="Franz, Alexander" userId="302c93c3-6320-4d3c-a68d-a1fdc247d2f3" providerId="ADAL" clId="{4B8A974F-5510-499D-8842-356C8A3E0C54}" dt="2025-06-16T20:09:58.816" v="9" actId="1038"/>
        <pc:sldMkLst>
          <pc:docMk/>
          <pc:sldMk cId="3770325497" sldId="260"/>
        </pc:sldMkLst>
        <pc:spChg chg="mod">
          <ac:chgData name="Franz, Alexander" userId="302c93c3-6320-4d3c-a68d-a1fdc247d2f3" providerId="ADAL" clId="{4B8A974F-5510-499D-8842-356C8A3E0C54}" dt="2025-06-16T19:49:43.172" v="2" actId="6549"/>
          <ac:spMkLst>
            <pc:docMk/>
            <pc:sldMk cId="3770325497" sldId="260"/>
            <ac:spMk id="40" creationId="{C779BEDC-45E8-6F28-197B-5875717BA5EC}"/>
          </ac:spMkLst>
        </pc:spChg>
        <pc:picChg chg="mod">
          <ac:chgData name="Franz, Alexander" userId="302c93c3-6320-4d3c-a68d-a1fdc247d2f3" providerId="ADAL" clId="{4B8A974F-5510-499D-8842-356C8A3E0C54}" dt="2025-06-16T20:09:58.816" v="9" actId="1038"/>
          <ac:picMkLst>
            <pc:docMk/>
            <pc:sldMk cId="3770325497" sldId="260"/>
            <ac:picMk id="33" creationId="{4F444252-CF51-F373-5B86-C8500BC3974D}"/>
          </ac:picMkLst>
        </pc:picChg>
      </pc:sldChg>
    </pc:docChg>
  </pc:docChgLst>
  <pc:docChgLst>
    <pc:chgData name="Franz, Alexander" userId="302c93c3-6320-4d3c-a68d-a1fdc247d2f3" providerId="ADAL" clId="{8F349B00-155A-41D8-9906-3FAD0BCB0079}"/>
    <pc:docChg chg="delSld">
      <pc:chgData name="Franz, Alexander" userId="302c93c3-6320-4d3c-a68d-a1fdc247d2f3" providerId="ADAL" clId="{8F349B00-155A-41D8-9906-3FAD0BCB0079}" dt="2025-05-09T15:15:15.585" v="5" actId="47"/>
      <pc:docMkLst>
        <pc:docMk/>
      </pc:docMkLst>
      <pc:sldChg chg="del">
        <pc:chgData name="Franz, Alexander" userId="302c93c3-6320-4d3c-a68d-a1fdc247d2f3" providerId="ADAL" clId="{8F349B00-155A-41D8-9906-3FAD0BCB0079}" dt="2025-05-09T15:15:12.291" v="0" actId="47"/>
        <pc:sldMkLst>
          <pc:docMk/>
          <pc:sldMk cId="3090315556" sldId="274"/>
        </pc:sldMkLst>
      </pc:sldChg>
      <pc:sldChg chg="del">
        <pc:chgData name="Franz, Alexander" userId="302c93c3-6320-4d3c-a68d-a1fdc247d2f3" providerId="ADAL" clId="{8F349B00-155A-41D8-9906-3FAD0BCB0079}" dt="2025-05-09T15:15:13.527" v="1" actId="47"/>
        <pc:sldMkLst>
          <pc:docMk/>
          <pc:sldMk cId="1558593817" sldId="282"/>
        </pc:sldMkLst>
      </pc:sldChg>
      <pc:sldChg chg="del">
        <pc:chgData name="Franz, Alexander" userId="302c93c3-6320-4d3c-a68d-a1fdc247d2f3" providerId="ADAL" clId="{8F349B00-155A-41D8-9906-3FAD0BCB0079}" dt="2025-05-09T15:15:15.585" v="5" actId="47"/>
        <pc:sldMkLst>
          <pc:docMk/>
          <pc:sldMk cId="738394285" sldId="283"/>
        </pc:sldMkLst>
      </pc:sldChg>
      <pc:sldChg chg="del">
        <pc:chgData name="Franz, Alexander" userId="302c93c3-6320-4d3c-a68d-a1fdc247d2f3" providerId="ADAL" clId="{8F349B00-155A-41D8-9906-3FAD0BCB0079}" dt="2025-05-09T15:15:14.050" v="2" actId="47"/>
        <pc:sldMkLst>
          <pc:docMk/>
          <pc:sldMk cId="3154073227" sldId="284"/>
        </pc:sldMkLst>
      </pc:sldChg>
      <pc:sldChg chg="del">
        <pc:chgData name="Franz, Alexander" userId="302c93c3-6320-4d3c-a68d-a1fdc247d2f3" providerId="ADAL" clId="{8F349B00-155A-41D8-9906-3FAD0BCB0079}" dt="2025-05-09T15:15:14.509" v="3" actId="47"/>
        <pc:sldMkLst>
          <pc:docMk/>
          <pc:sldMk cId="342682865" sldId="288"/>
        </pc:sldMkLst>
      </pc:sldChg>
      <pc:sldChg chg="del">
        <pc:chgData name="Franz, Alexander" userId="302c93c3-6320-4d3c-a68d-a1fdc247d2f3" providerId="ADAL" clId="{8F349B00-155A-41D8-9906-3FAD0BCB0079}" dt="2025-05-09T15:15:14.953" v="4" actId="47"/>
        <pc:sldMkLst>
          <pc:docMk/>
          <pc:sldMk cId="569847685" sldId="28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D2B3F1-9DE9-4B62-87EA-66A776D0C75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285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C779BEDC-45E8-6F28-197B-5875717BA5EC}"/>
              </a:ext>
            </a:extLst>
          </p:cNvPr>
          <p:cNvSpPr txBox="1"/>
          <p:nvPr/>
        </p:nvSpPr>
        <p:spPr>
          <a:xfrm>
            <a:off x="808115" y="776594"/>
            <a:ext cx="100140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/>
              <a:t>S1 Table (A-C). Gene drive carriers by sex</a:t>
            </a:r>
            <a:endParaRPr lang="en-US" sz="36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F17C332-05F0-22F1-4B83-A099D342E6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91448" y="2616773"/>
            <a:ext cx="6595988" cy="1006677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C0679CC-3659-42AB-34D9-7413F27A5C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98171" y="2599681"/>
            <a:ext cx="7111921" cy="1006677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1D934FE3-CC30-0405-9AFB-B49FF9623843}"/>
              </a:ext>
            </a:extLst>
          </p:cNvPr>
          <p:cNvSpPr txBox="1"/>
          <p:nvPr/>
        </p:nvSpPr>
        <p:spPr>
          <a:xfrm>
            <a:off x="748640" y="1954030"/>
            <a:ext cx="6171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A.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BDFB24E-23FE-FA8F-9C2A-F384A638F2B8}"/>
              </a:ext>
            </a:extLst>
          </p:cNvPr>
          <p:cNvSpPr txBox="1"/>
          <p:nvPr/>
        </p:nvSpPr>
        <p:spPr>
          <a:xfrm>
            <a:off x="8698764" y="1954030"/>
            <a:ext cx="6040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B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F61C7EC-E4FD-7961-587B-DAAA34AB8465}"/>
              </a:ext>
            </a:extLst>
          </p:cNvPr>
          <p:cNvSpPr txBox="1"/>
          <p:nvPr/>
        </p:nvSpPr>
        <p:spPr>
          <a:xfrm>
            <a:off x="808115" y="13776231"/>
            <a:ext cx="6427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/>
              <a:t>C.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4F444252-CF51-F373-5B86-C8500BC397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23574" y="14562831"/>
            <a:ext cx="6453948" cy="61246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C852052-E19D-065D-B84D-11E6EDF42D69}"/>
              </a:ext>
            </a:extLst>
          </p:cNvPr>
          <p:cNvSpPr txBox="1"/>
          <p:nvPr/>
        </p:nvSpPr>
        <p:spPr>
          <a:xfrm>
            <a:off x="1490570" y="12766166"/>
            <a:ext cx="15120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F-35 = </a:t>
            </a:r>
            <a:r>
              <a:rPr lang="en-US" sz="2400" i="1" dirty="0"/>
              <a:t>Ae. aegypti </a:t>
            </a:r>
            <a:r>
              <a:rPr lang="en-US" sz="2400" dirty="0"/>
              <a:t>carrying </a:t>
            </a:r>
            <a:r>
              <a:rPr lang="en-US" sz="2400" i="1" dirty="0"/>
              <a:t>nanos</a:t>
            </a:r>
            <a:r>
              <a:rPr lang="en-US" sz="2400" dirty="0"/>
              <a:t>-GD transgene; AF-46 = </a:t>
            </a:r>
            <a:r>
              <a:rPr lang="en-US" sz="2400" i="1" dirty="0"/>
              <a:t>Ae. aegypti </a:t>
            </a:r>
            <a:r>
              <a:rPr lang="en-US" sz="2400" dirty="0"/>
              <a:t>carrying </a:t>
            </a:r>
            <a:r>
              <a:rPr lang="en-US" sz="2400" i="1" dirty="0" err="1"/>
              <a:t>zpg</a:t>
            </a:r>
            <a:r>
              <a:rPr lang="en-US" sz="2400" dirty="0"/>
              <a:t>-GD transgene in Experiment A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2DAF117-A138-FFCF-8646-861F2DA1EAA5}"/>
              </a:ext>
            </a:extLst>
          </p:cNvPr>
          <p:cNvSpPr txBox="1"/>
          <p:nvPr/>
        </p:nvSpPr>
        <p:spPr>
          <a:xfrm>
            <a:off x="1450855" y="2032590"/>
            <a:ext cx="176683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/>
              <a:t>nanos</a:t>
            </a:r>
            <a:r>
              <a:rPr lang="en-US" sz="2800" dirty="0"/>
              <a:t>-G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A2B5D8-0048-8FAA-48C5-8BB2E9FBEC27}"/>
              </a:ext>
            </a:extLst>
          </p:cNvPr>
          <p:cNvSpPr txBox="1"/>
          <p:nvPr/>
        </p:nvSpPr>
        <p:spPr>
          <a:xfrm>
            <a:off x="9391448" y="2032590"/>
            <a:ext cx="134203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i="1" dirty="0" err="1"/>
              <a:t>zpg</a:t>
            </a:r>
            <a:r>
              <a:rPr lang="en-US" sz="2800" dirty="0"/>
              <a:t>-G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5B51D8-4D82-9FDD-643D-58CD29E8EA49}"/>
              </a:ext>
            </a:extLst>
          </p:cNvPr>
          <p:cNvSpPr txBox="1"/>
          <p:nvPr/>
        </p:nvSpPr>
        <p:spPr>
          <a:xfrm>
            <a:off x="1490570" y="13864798"/>
            <a:ext cx="875893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Fisher’s exact test results for sex bias in GD inheritance.</a:t>
            </a:r>
          </a:p>
        </p:txBody>
      </p:sp>
    </p:spTree>
    <p:extLst>
      <p:ext uri="{BB962C8B-B14F-4D97-AF65-F5344CB8AC3E}">
        <p14:creationId xmlns:p14="http://schemas.microsoft.com/office/powerpoint/2010/main" val="3770325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4</TotalTime>
  <Words>51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6-16T20:10:05Z</dcterms:modified>
</cp:coreProperties>
</file>